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th-TH"/>
    </a:defPPr>
    <a:lvl1pPr marL="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สไตล์สีปานกลาง 2 - เน้น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74" d="100"/>
          <a:sy n="74" d="100"/>
        </p:scale>
        <p:origin x="340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สไลด์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4D8BCCFB-139E-8833-C0FD-8B261E32EEF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ชื่อเรื่องรอง 2">
            <a:extLst>
              <a:ext uri="{FF2B5EF4-FFF2-40B4-BE49-F238E27FC236}">
                <a16:creationId xmlns:a16="http://schemas.microsoft.com/office/drawing/2014/main" id="{F818A6D2-9355-EBCC-00AE-E82F8FF0536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th-TH"/>
              <a:t>คลิกเพื่อแก้ไขสไตล์ชื่อเรื่องรองต้นแบบ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FC91F78E-4820-A2CF-C845-C786B0D780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50CFB5-4AC4-4CFD-9BBE-2D12FD0A5FAA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82B1120F-066D-049B-661F-969B682CDC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18F2C051-23E7-0779-DEBE-3622404840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4D83F6-0680-4F48-97F2-FD4A18076D8B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0942124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ชื่อเรื่องและข้อความ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0692312C-66BF-894B-2B6E-2884196EFF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แนวตั้ง 2">
            <a:extLst>
              <a:ext uri="{FF2B5EF4-FFF2-40B4-BE49-F238E27FC236}">
                <a16:creationId xmlns:a16="http://schemas.microsoft.com/office/drawing/2014/main" id="{DFC1B7AB-E32A-298C-F124-5875F339C2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F91121DA-3BC2-D424-EF69-251FB12C82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50CFB5-4AC4-4CFD-9BBE-2D12FD0A5FAA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4010ED8B-8AD3-8D46-725E-405B14193B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6BC15B7C-6CDF-FFA7-6C7D-F156CF2133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4D83F6-0680-4F48-97F2-FD4A18076D8B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0244279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ข้อความและชื่อเรื่อง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แนวตั้ง 1">
            <a:extLst>
              <a:ext uri="{FF2B5EF4-FFF2-40B4-BE49-F238E27FC236}">
                <a16:creationId xmlns:a16="http://schemas.microsoft.com/office/drawing/2014/main" id="{D0BCDDE5-9FA2-EDFC-6A57-F785925939D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แนวตั้ง 2">
            <a:extLst>
              <a:ext uri="{FF2B5EF4-FFF2-40B4-BE49-F238E27FC236}">
                <a16:creationId xmlns:a16="http://schemas.microsoft.com/office/drawing/2014/main" id="{9C00E96F-AB0B-D39B-CCE7-E9263C0E5B8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E1D8CB9A-32C1-1B10-4AC7-742A41D0CD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50CFB5-4AC4-4CFD-9BBE-2D12FD0A5FAA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435A0C65-10D0-819F-5B00-6A7A52C0B9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CA826285-57A2-DF62-33F0-9869691F2C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4D83F6-0680-4F48-97F2-FD4A18076D8B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41653723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ชื่อเรื่องและเนื้อห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175202A9-276C-F4BD-6926-53332AAC2E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47069C24-2FB5-417F-3D6B-B2E56F79283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5F964967-2364-C838-CDCB-0B6667845C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50CFB5-4AC4-4CFD-9BBE-2D12FD0A5FAA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A4614592-33E1-EEDB-E7B3-0D1569B582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6485ABFF-661D-A7D5-6373-17FB14B83D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4D83F6-0680-4F48-97F2-FD4A18076D8B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295023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ส่วนหัวของ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C231725E-BB33-87D5-BAAF-9200428939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0083D462-4560-FE7C-9ECE-C5C4CF0103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F9DFB623-605A-D786-F6B9-5116B84CC4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50CFB5-4AC4-4CFD-9BBE-2D12FD0A5FAA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F04E031E-0587-E8D7-CAA7-365BBC3A3D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162D18A5-B776-5153-D29D-412B5C0C7D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4D83F6-0680-4F48-97F2-FD4A18076D8B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9673838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เนื้อหา 2 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34C5DF63-40D5-71BC-4718-DA1E3D1F8D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ADD3C655-0D5A-767A-A8FC-3A30483240E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เนื้อหา 3">
            <a:extLst>
              <a:ext uri="{FF2B5EF4-FFF2-40B4-BE49-F238E27FC236}">
                <a16:creationId xmlns:a16="http://schemas.microsoft.com/office/drawing/2014/main" id="{215B57EC-7C4F-4E14-EC5F-7876A943F5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1695CA2E-08FF-5419-9F32-39EFB3BCBA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50CFB5-4AC4-4CFD-9BBE-2D12FD0A5FAA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18635842-DBBB-125F-3524-A902D0F715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A52D3D22-A07F-C326-554C-27BA261F7D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4D83F6-0680-4F48-97F2-FD4A18076D8B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7324160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การเปรียบเทียบ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FFC95046-117C-9B06-C1AA-990FAD5936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79A0AB06-86E0-1D70-E6AD-78C9223F6A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4" name="ตัวแทนเนื้อหา 3">
            <a:extLst>
              <a:ext uri="{FF2B5EF4-FFF2-40B4-BE49-F238E27FC236}">
                <a16:creationId xmlns:a16="http://schemas.microsoft.com/office/drawing/2014/main" id="{9D8FCD70-4F06-1F84-9585-59A246E369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5" name="ตัวแทนข้อความ 4">
            <a:extLst>
              <a:ext uri="{FF2B5EF4-FFF2-40B4-BE49-F238E27FC236}">
                <a16:creationId xmlns:a16="http://schemas.microsoft.com/office/drawing/2014/main" id="{C2009AC0-8C67-025F-51C4-311B7C5EB5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6" name="ตัวแทนเนื้อหา 5">
            <a:extLst>
              <a:ext uri="{FF2B5EF4-FFF2-40B4-BE49-F238E27FC236}">
                <a16:creationId xmlns:a16="http://schemas.microsoft.com/office/drawing/2014/main" id="{93DA7325-3791-587E-534A-F7B67EC3B19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7" name="ตัวแทนวันที่ 6">
            <a:extLst>
              <a:ext uri="{FF2B5EF4-FFF2-40B4-BE49-F238E27FC236}">
                <a16:creationId xmlns:a16="http://schemas.microsoft.com/office/drawing/2014/main" id="{D84658C9-F4C4-7568-6277-90F01028F8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50CFB5-4AC4-4CFD-9BBE-2D12FD0A5FAA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8" name="ตัวแทนท้ายกระดาษ 7">
            <a:extLst>
              <a:ext uri="{FF2B5EF4-FFF2-40B4-BE49-F238E27FC236}">
                <a16:creationId xmlns:a16="http://schemas.microsoft.com/office/drawing/2014/main" id="{CA8F731A-CD83-0930-67AD-2801521948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9" name="ตัวแทนหมายเลขสไลด์ 8">
            <a:extLst>
              <a:ext uri="{FF2B5EF4-FFF2-40B4-BE49-F238E27FC236}">
                <a16:creationId xmlns:a16="http://schemas.microsoft.com/office/drawing/2014/main" id="{CCE5DD43-4337-311B-CFBC-6DB6871F2B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4D83F6-0680-4F48-97F2-FD4A18076D8B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9932273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เฉพาะ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96559F98-C984-17AA-7D65-EC0BE2BDF8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วันที่ 2">
            <a:extLst>
              <a:ext uri="{FF2B5EF4-FFF2-40B4-BE49-F238E27FC236}">
                <a16:creationId xmlns:a16="http://schemas.microsoft.com/office/drawing/2014/main" id="{0D67E2DC-B434-AB09-4ABE-D872480483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50CFB5-4AC4-4CFD-9BBE-2D12FD0A5FAA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4" name="ตัวแทนท้ายกระดาษ 3">
            <a:extLst>
              <a:ext uri="{FF2B5EF4-FFF2-40B4-BE49-F238E27FC236}">
                <a16:creationId xmlns:a16="http://schemas.microsoft.com/office/drawing/2014/main" id="{F27C0487-D876-A18E-7E04-9C78402CC4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5" name="ตัวแทนหมายเลขสไลด์ 4">
            <a:extLst>
              <a:ext uri="{FF2B5EF4-FFF2-40B4-BE49-F238E27FC236}">
                <a16:creationId xmlns:a16="http://schemas.microsoft.com/office/drawing/2014/main" id="{BAF34876-A01C-7DF8-27EE-975362E1C2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4D83F6-0680-4F48-97F2-FD4A18076D8B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8827670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ว่างเปล่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ตัวแทนวันที่ 1">
            <a:extLst>
              <a:ext uri="{FF2B5EF4-FFF2-40B4-BE49-F238E27FC236}">
                <a16:creationId xmlns:a16="http://schemas.microsoft.com/office/drawing/2014/main" id="{3A168EB9-570D-BC7F-73F3-256A0A5035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50CFB5-4AC4-4CFD-9BBE-2D12FD0A5FAA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3" name="ตัวแทนท้ายกระดาษ 2">
            <a:extLst>
              <a:ext uri="{FF2B5EF4-FFF2-40B4-BE49-F238E27FC236}">
                <a16:creationId xmlns:a16="http://schemas.microsoft.com/office/drawing/2014/main" id="{1C9253DA-1D44-3305-28DC-CF6883224C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4" name="ตัวแทนหมายเลขสไลด์ 3">
            <a:extLst>
              <a:ext uri="{FF2B5EF4-FFF2-40B4-BE49-F238E27FC236}">
                <a16:creationId xmlns:a16="http://schemas.microsoft.com/office/drawing/2014/main" id="{038AE5A6-2999-55FA-A3AD-6982F2687A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4D83F6-0680-4F48-97F2-FD4A18076D8B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7412360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เนื้อหา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DEEBAD9A-DEBC-9682-25CA-340278E60E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5DBD3D21-07CB-82BB-4D64-55066473F47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ข้อความ 3">
            <a:extLst>
              <a:ext uri="{FF2B5EF4-FFF2-40B4-BE49-F238E27FC236}">
                <a16:creationId xmlns:a16="http://schemas.microsoft.com/office/drawing/2014/main" id="{4135564A-8F61-E03D-9ABC-C457972D70C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37ADFFC7-8E2D-0EB8-DDB4-E27D85E408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50CFB5-4AC4-4CFD-9BBE-2D12FD0A5FAA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DE7820B0-3E27-7D5C-4010-7A37733B8F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A36DBAA8-44F8-24A4-68B5-E1CE677629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4D83F6-0680-4F48-97F2-FD4A18076D8B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8219523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รูปภาพ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3BD244AE-8A64-95D6-FDAD-948093BAF5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รูปภาพ 2">
            <a:extLst>
              <a:ext uri="{FF2B5EF4-FFF2-40B4-BE49-F238E27FC236}">
                <a16:creationId xmlns:a16="http://schemas.microsoft.com/office/drawing/2014/main" id="{777E2A64-ABD5-66FE-CA46-2186681EB0D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th-TH"/>
          </a:p>
        </p:txBody>
      </p:sp>
      <p:sp>
        <p:nvSpPr>
          <p:cNvPr id="4" name="ตัวแทนข้อความ 3">
            <a:extLst>
              <a:ext uri="{FF2B5EF4-FFF2-40B4-BE49-F238E27FC236}">
                <a16:creationId xmlns:a16="http://schemas.microsoft.com/office/drawing/2014/main" id="{ABEC8142-3A9E-7B5A-1B71-6D542997AC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325B9822-0B56-9DBE-4743-87B88CEAE1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50CFB5-4AC4-4CFD-9BBE-2D12FD0A5FAA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EB4BCC94-6D37-3DA5-104D-43752466F8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CD3FA04E-9859-7313-3442-A4BDD6E5F9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4D83F6-0680-4F48-97F2-FD4A18076D8B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7724748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ตัวแทนชื่อเรื่อง 1">
            <a:extLst>
              <a:ext uri="{FF2B5EF4-FFF2-40B4-BE49-F238E27FC236}">
                <a16:creationId xmlns:a16="http://schemas.microsoft.com/office/drawing/2014/main" id="{8FD30454-247A-E60B-711A-AA5F0D829C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64A6DB04-9391-02C9-5F5E-1560031D8E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608640EE-0252-E4AA-A23C-16FA3420011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50CFB5-4AC4-4CFD-9BBE-2D12FD0A5FAA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5519E8B1-32ED-8992-9ABD-D90B8B701D5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3F228547-F2DB-B579-7B0C-2183BB7757A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4D83F6-0680-4F48-97F2-FD4A18076D8B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208464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h-TH"/>
      </a:defPPr>
      <a:lvl1pPr marL="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ตาราง 6">
            <a:extLst>
              <a:ext uri="{FF2B5EF4-FFF2-40B4-BE49-F238E27FC236}">
                <a16:creationId xmlns:a16="http://schemas.microsoft.com/office/drawing/2014/main" id="{90A2E643-627A-47FA-E7D5-8F6FF3382F7C}"/>
              </a:ext>
            </a:extLst>
          </p:cNvPr>
          <p:cNvGraphicFramePr>
            <a:graphicFrameLocks noGrp="1"/>
          </p:cNvGraphicFramePr>
          <p:nvPr/>
        </p:nvGraphicFramePr>
        <p:xfrm>
          <a:off x="838200" y="2563908"/>
          <a:ext cx="10515601" cy="2874772"/>
        </p:xfrm>
        <a:graphic>
          <a:graphicData uri="http://schemas.openxmlformats.org/drawingml/2006/table">
            <a:tbl>
              <a:tblPr firstRow="1" firstCol="1" bandRow="1"/>
              <a:tblGrid>
                <a:gridCol w="488022">
                  <a:extLst>
                    <a:ext uri="{9D8B030D-6E8A-4147-A177-3AD203B41FA5}">
                      <a16:colId xmlns:a16="http://schemas.microsoft.com/office/drawing/2014/main" val="1413652291"/>
                    </a:ext>
                  </a:extLst>
                </a:gridCol>
                <a:gridCol w="1209536">
                  <a:extLst>
                    <a:ext uri="{9D8B030D-6E8A-4147-A177-3AD203B41FA5}">
                      <a16:colId xmlns:a16="http://schemas.microsoft.com/office/drawing/2014/main" val="2644477866"/>
                    </a:ext>
                  </a:extLst>
                </a:gridCol>
                <a:gridCol w="881383">
                  <a:extLst>
                    <a:ext uri="{9D8B030D-6E8A-4147-A177-3AD203B41FA5}">
                      <a16:colId xmlns:a16="http://schemas.microsoft.com/office/drawing/2014/main" val="2150015720"/>
                    </a:ext>
                  </a:extLst>
                </a:gridCol>
                <a:gridCol w="2349655">
                  <a:extLst>
                    <a:ext uri="{9D8B030D-6E8A-4147-A177-3AD203B41FA5}">
                      <a16:colId xmlns:a16="http://schemas.microsoft.com/office/drawing/2014/main" val="3637186557"/>
                    </a:ext>
                  </a:extLst>
                </a:gridCol>
                <a:gridCol w="1478789">
                  <a:extLst>
                    <a:ext uri="{9D8B030D-6E8A-4147-A177-3AD203B41FA5}">
                      <a16:colId xmlns:a16="http://schemas.microsoft.com/office/drawing/2014/main" val="4026446967"/>
                    </a:ext>
                  </a:extLst>
                </a:gridCol>
                <a:gridCol w="1150637">
                  <a:extLst>
                    <a:ext uri="{9D8B030D-6E8A-4147-A177-3AD203B41FA5}">
                      <a16:colId xmlns:a16="http://schemas.microsoft.com/office/drawing/2014/main" val="2943326189"/>
                    </a:ext>
                  </a:extLst>
                </a:gridCol>
                <a:gridCol w="984457">
                  <a:extLst>
                    <a:ext uri="{9D8B030D-6E8A-4147-A177-3AD203B41FA5}">
                      <a16:colId xmlns:a16="http://schemas.microsoft.com/office/drawing/2014/main" val="1608147728"/>
                    </a:ext>
                  </a:extLst>
                </a:gridCol>
                <a:gridCol w="1152741">
                  <a:extLst>
                    <a:ext uri="{9D8B030D-6E8A-4147-A177-3AD203B41FA5}">
                      <a16:colId xmlns:a16="http://schemas.microsoft.com/office/drawing/2014/main" val="2886197256"/>
                    </a:ext>
                  </a:extLst>
                </a:gridCol>
                <a:gridCol w="820381">
                  <a:extLst>
                    <a:ext uri="{9D8B030D-6E8A-4147-A177-3AD203B41FA5}">
                      <a16:colId xmlns:a16="http://schemas.microsoft.com/office/drawing/2014/main" val="1238421498"/>
                    </a:ext>
                  </a:extLst>
                </a:gridCol>
              </a:tblGrid>
              <a:tr h="63627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ordia New" panose="020B0304020202020204" pitchFamily="34" charset="-34"/>
                        </a:rPr>
                        <a:t>No.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ordia New" panose="020B0304020202020204" pitchFamily="34" charset="-34"/>
                        </a:rPr>
                        <a:t>m/z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ordia New" panose="020B0304020202020204" pitchFamily="34" charset="-34"/>
                        </a:rPr>
                        <a:t>RT (min)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ordia New" panose="020B0304020202020204" pitchFamily="34" charset="-34"/>
                        </a:rPr>
                        <a:t>Name of the compound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ordia New" panose="020B0304020202020204" pitchFamily="34" charset="-34"/>
                        </a:rPr>
                        <a:t>Molecular Formulae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ordia New" panose="020B0304020202020204" pitchFamily="34" charset="-34"/>
                        </a:rPr>
                        <a:t>Molecular weight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ordia New" panose="020B0304020202020204" pitchFamily="34" charset="-34"/>
                        </a:rPr>
                        <a:t>%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ordia New" panose="020B0304020202020204" pitchFamily="34" charset="-34"/>
                        </a:rPr>
                        <a:t> Con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ordia New" panose="020B0304020202020204" pitchFamily="34" charset="-34"/>
                        </a:rPr>
                        <a:t>tent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ordia New" panose="020B0304020202020204" pitchFamily="34" charset="-34"/>
                        </a:rPr>
                        <a:t>Matching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ordia New" panose="020B0304020202020204" pitchFamily="34" charset="-34"/>
                        </a:rPr>
                        <a:t>Score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ordia New" panose="020B0304020202020204" pitchFamily="34" charset="-34"/>
                        </a:rPr>
                        <a:t>Diff (DB, ppm)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76561602"/>
                  </a:ext>
                </a:extLst>
              </a:tr>
              <a:tr h="37160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ordia New" panose="020B0304020202020204" pitchFamily="34" charset="-34"/>
                        </a:rPr>
                        <a:t>1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163.0389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9.205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4-Hydroxycoumarin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C9 H6 O3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162.03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2.20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800" kern="100">
                          <a:solidFill>
                            <a:srgbClr val="000000"/>
                          </a:solidFill>
                          <a:effectLst/>
                          <a:latin typeface="Segoe UI" panose="020B0502040204020203" pitchFamily="34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90.87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 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0.2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5720113"/>
                  </a:ext>
                </a:extLst>
              </a:tr>
              <a:tr h="26670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ordia New" panose="020B0304020202020204" pitchFamily="34" charset="-34"/>
                        </a:rPr>
                        <a:t>2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449.1088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9.406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Astragalin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C21 H20 O11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448.10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1.05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93.94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-1.65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14845839"/>
                  </a:ext>
                </a:extLst>
              </a:tr>
              <a:tr h="26670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ordia New" panose="020B0304020202020204" pitchFamily="34" charset="-34"/>
                        </a:rPr>
                        <a:t>3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271.0597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11.063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Apigenin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C15 H10 O5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270.05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0.72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93.44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1.34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70039120"/>
                  </a:ext>
                </a:extLst>
              </a:tr>
              <a:tr h="26670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ordia New" panose="020B0304020202020204" pitchFamily="34" charset="-34"/>
                        </a:rPr>
                        <a:t>4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447.0929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11.101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Baicalin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C21 H18 O11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446.08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1.82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96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-1.41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5449634"/>
                  </a:ext>
                </a:extLst>
              </a:tr>
              <a:tr h="26670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ordia New" panose="020B0304020202020204" pitchFamily="34" charset="-34"/>
                        </a:rPr>
                        <a:t>5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271.0601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17.478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Genistein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C15 H10 O5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270.05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1.64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90.49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0.05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34059643"/>
                  </a:ext>
                </a:extLst>
              </a:tr>
              <a:tr h="26670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ordia New" panose="020B0304020202020204" pitchFamily="34" charset="-34"/>
                        </a:rPr>
                        <a:t>6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373.1987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25.701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Lipoxin A5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C20 H30 O5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350.20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0.40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92.9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-0.3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7507146"/>
                  </a:ext>
                </a:extLst>
              </a:tr>
              <a:tr h="26670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ordia New" panose="020B0304020202020204" pitchFamily="34" charset="-34"/>
                        </a:rPr>
                        <a:t>7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293.2112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32.267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9-OxoOTrE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C18 H28 O3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292.20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0.41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91.44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0.17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65267475"/>
                  </a:ext>
                </a:extLst>
              </a:tr>
              <a:tr h="26670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Cordia New" panose="020B0304020202020204" pitchFamily="34" charset="-34"/>
                        </a:rPr>
                        <a:t>8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496.3399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32.732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1-Palmitoyllysophosphatidylcholine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C24 H51 N O7 P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496.34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0.55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92.73</a:t>
                      </a:r>
                      <a:endParaRPr lang="en-US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9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Cordia New" panose="020B0304020202020204" pitchFamily="34" charset="-34"/>
                        </a:rPr>
                        <a:t>0.08</a:t>
                      </a:r>
                      <a:endParaRPr lang="en-US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37077605"/>
                  </a:ext>
                </a:extLst>
              </a:tr>
            </a:tbl>
          </a:graphicData>
        </a:graphic>
      </p:graphicFrame>
      <p:sp>
        <p:nvSpPr>
          <p:cNvPr id="9" name="กล่องข้อความ 8">
            <a:extLst>
              <a:ext uri="{FF2B5EF4-FFF2-40B4-BE49-F238E27FC236}">
                <a16:creationId xmlns:a16="http://schemas.microsoft.com/office/drawing/2014/main" id="{69F69094-47F4-925E-EE35-D1A0C4119EC2}"/>
              </a:ext>
            </a:extLst>
          </p:cNvPr>
          <p:cNvSpPr txBox="1"/>
          <p:nvPr/>
        </p:nvSpPr>
        <p:spPr>
          <a:xfrm>
            <a:off x="1086927" y="859559"/>
            <a:ext cx="10817525" cy="503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Supplementary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Cordia New" panose="020B0304020202020204" pitchFamily="34" charset="-34"/>
              </a:rPr>
              <a:t> Table S3</a:t>
            </a:r>
            <a:r>
              <a:rPr lang="th-TH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Cordia New" panose="020B0304020202020204" pitchFamily="34" charset="-34"/>
              </a:rPr>
              <a:t> 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Cordia New" panose="020B0304020202020204" pitchFamily="34" charset="-34"/>
              </a:rPr>
              <a:t>Compounds identified in the </a:t>
            </a:r>
            <a:r>
              <a:rPr lang="en-US" sz="1200" b="1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Cordia New" panose="020B0304020202020204" pitchFamily="34" charset="-34"/>
              </a:rPr>
              <a:t>Clerodendrum </a:t>
            </a:r>
            <a:r>
              <a:rPr lang="en-US" sz="1200" b="1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Cordia New" panose="020B0304020202020204" pitchFamily="34" charset="-34"/>
              </a:rPr>
              <a:t>serratum</a:t>
            </a:r>
            <a:r>
              <a:rPr lang="en-US" sz="1200" b="1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Cordia New" panose="020B0304020202020204" pitchFamily="34" charset="-34"/>
              </a:rPr>
              <a:t>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Cordia New" panose="020B0304020202020204" pitchFamily="34" charset="-34"/>
              </a:rPr>
              <a:t>Linn.) Moon (CSM) drying with dehydration chamber via positive electrospray ionization (ESI+) LC-MS analysis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1929172349"/>
      </p:ext>
    </p:extLst>
  </p:cSld>
  <p:clrMapOvr>
    <a:masterClrMapping/>
  </p:clrMapOvr>
</p:sld>
</file>

<file path=ppt/theme/theme1.xml><?xml version="1.0" encoding="utf-8"?>
<a:theme xmlns:a="http://schemas.openxmlformats.org/drawingml/2006/main" name="ธีมของ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53</Words>
  <Application>Microsoft Office PowerPoint</Application>
  <PresentationFormat>แบบจอกว้าง</PresentationFormat>
  <Paragraphs>86</Paragraphs>
  <Slides>1</Slides>
  <Notes>0</Notes>
  <HiddenSlides>0</HiddenSlides>
  <MMClips>0</MMClips>
  <ScaleCrop>false</ScaleCrop>
  <HeadingPairs>
    <vt:vector size="6" baseType="variant">
      <vt:variant>
        <vt:lpstr>ฟอนต์ที่ถูกใช้</vt:lpstr>
      </vt:variant>
      <vt:variant>
        <vt:i4>5</vt:i4>
      </vt:variant>
      <vt:variant>
        <vt:lpstr>ธีม</vt:lpstr>
      </vt:variant>
      <vt:variant>
        <vt:i4>1</vt:i4>
      </vt:variant>
      <vt:variant>
        <vt:lpstr>ชื่อเรื่องสไลด์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egoe UI</vt:lpstr>
      <vt:lpstr>Times New Roman</vt:lpstr>
      <vt:lpstr>ธีมของ Office</vt:lpstr>
      <vt:lpstr>งานนำเสนอ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กิ่งกาญจน์ บรรลือพืช</dc:creator>
  <cp:lastModifiedBy>กิ่งกาญจน์ บรรลือพืช</cp:lastModifiedBy>
  <cp:revision>1</cp:revision>
  <dcterms:created xsi:type="dcterms:W3CDTF">2026-02-22T09:20:52Z</dcterms:created>
  <dcterms:modified xsi:type="dcterms:W3CDTF">2026-02-22T09:23:05Z</dcterms:modified>
</cp:coreProperties>
</file>